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3"/>
  </p:normalViewPr>
  <p:slideViewPr>
    <p:cSldViewPr snapToGrid="0">
      <p:cViewPr varScale="1">
        <p:scale>
          <a:sx n="115" d="100"/>
          <a:sy n="115" d="100"/>
        </p:scale>
        <p:origin x="10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C17AA-4506-7BE9-1A39-4B3FCF863B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80B018-D380-8E9D-86F6-27109F0173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2FC343-B435-C65C-9ACC-22D91025E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28204-BC81-9D2E-AE3C-B7169F340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7AAD7-F4A8-72EA-BBB0-91CB74A72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20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18FA9-F001-89A9-C69C-AB9F7E3F23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7F3145-5802-922C-77A1-4D35C51E23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47068-0D62-78B5-07E5-745FB914D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32DE93-C2E0-1FB0-3803-BD8234350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1DFF1C-0FAA-86A3-0291-72990ABCA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874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E738E4-CEA6-9FE4-9300-DB3FFF51C7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F3A249-F39F-AACC-57BB-8270A9E4F9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76E1B-BCEA-89C5-2CCC-8FD033E79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F2E7A-BE29-1D4E-2AC5-6BE7300F7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2A699F-F0F8-A90D-628C-9671646D4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9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C93E1-14CE-C505-75A8-A94970CD8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257D80-14FB-F369-9F6E-F134527BCB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A30706-1DAF-A8C2-565D-498844A57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22F021-E4A5-D773-5B00-498DB959C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FED3E-1A6F-D6C5-F0C4-F87B699AE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02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0CC40-D2D7-B648-5DF3-EF8794FD1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D95989-04A6-11EB-E618-A01924F955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60431C-53E7-B4F1-C443-95D9A2E12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00EA3-6402-12FE-048C-0E6BFE120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7C907A-97CA-BBD4-581C-73FF38CE4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7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33181-F891-E100-D917-2008951CA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2584DD-D092-0140-3B2B-FA03FE83A1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6557E7-F912-839D-09E6-7443DDAF02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607671-8DAD-6058-745F-831FD12C2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BA58C6-EE60-60C7-208E-2A41D40B9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B2BCC3-A064-46D7-E5D9-37FB7A6AA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110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D3438-8F03-19F2-10D1-DE88F427A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76BA77-841A-CEFC-09CB-EBEB06827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8B8BCD-56F8-C0A1-6244-4666297DC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044421-26B9-30E8-C5CA-97FDE019CA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DC50DB-E59B-39C1-A8A5-2C82FA880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502B12-9BE1-FBCF-33E9-E1386E594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1156F1-B816-D95D-504E-3AFF67C5B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BA33C5-6057-8C86-87B5-944C4214E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506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2996D4-BF9B-84FB-94B5-A7C0502FF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C34B30-6FAC-8FCE-4635-8B07F0032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DC9CF7-2AD5-9321-88F5-F9C31EFF2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186AFA-0892-6B0B-D171-06CEC6DE5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2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ADA56C-2226-49E2-C5DA-35245EF10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369DFA-8F80-A8C4-1929-45E3D00E6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3CCA82-04F4-85B7-CFB6-DA6D0A5E1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222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AC696-1CE4-ECF7-7662-AD2F4B19C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B9AD4C-E4A4-1BC8-7E23-238432E61E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B48F4B-64FB-5F58-169E-48CF5FCF9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87E2DE-2408-C67D-56E9-9A136DEFC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8C8701-8381-5727-55BE-C4468DF0A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03D17A-DDAF-7340-BC5D-25FA872E8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273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296CA-8F94-6929-A384-3CA39989A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8ACB2BB-A881-F627-AAA1-3A1225794D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17976E-4B3D-899D-D923-F3BFD163FD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71AB66-C4F4-82A3-C887-1792206EB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2C82-36B1-79DA-F129-B5BA531FB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B53BAA-CCAD-227A-BE04-713F5EAF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195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4DF18D-6095-DB1A-43D6-6456EE6C1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01355C-7570-5E06-3FB3-3E5886F67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AF9F2-520A-6D31-7067-7C1769930F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167B4B-BE97-A296-CF62-4AA0F51FC6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5F8683-9C8E-D15A-C104-97A0EB3FCD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31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upplementary_Video_1.mov">
            <a:hlinkClick r:id="" action="ppaction://media"/>
            <a:extLst>
              <a:ext uri="{FF2B5EF4-FFF2-40B4-BE49-F238E27FC236}">
                <a16:creationId xmlns:a16="http://schemas.microsoft.com/office/drawing/2014/main" id="{FA3B88D3-57D5-243F-E7CD-824FC3FE6E1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86189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0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BD16C97-7386-FB8D-59A1-226650F4D59C}"/>
              </a:ext>
            </a:extLst>
          </p:cNvPr>
          <p:cNvSpPr txBox="1"/>
          <p:nvPr/>
        </p:nvSpPr>
        <p:spPr>
          <a:xfrm>
            <a:off x="1442739" y="548393"/>
            <a:ext cx="9306521" cy="51474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Supplementary Video 1</a:t>
            </a:r>
            <a:endParaRPr lang="en-US" sz="18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marL="0" marR="0" algn="just">
              <a:lnSpc>
                <a:spcPct val="200000"/>
              </a:lnSpc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3D reconstitution of the p53-PITP</a:t>
            </a:r>
            <a:r>
              <a:rPr lang="el-GR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β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complex in the nucleoplasm of MDA-MB-231 cells under basal conditions </a:t>
            </a:r>
            <a:endParaRPr lang="en-US" sz="18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marL="0" marR="0" algn="just">
              <a:lnSpc>
                <a:spcPct val="200000"/>
              </a:lnSpc>
              <a:spcAft>
                <a:spcPts val="12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MDA-MB-231 cells were treated with control vehicle for 24 h before being processed for PLA between p53 and PITP</a:t>
            </a:r>
            <a:r>
              <a:rPr lang="el-GR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β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(Red). Lamin A/C stained the nuclear envelope (Green), and the nuclei were counter-stained with DAPI (Blue)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z-stack images were taken with a Leica SP8 confocal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microscope with each frame over a 0.2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m thickness. The video of the 3D reconstitution of a representative cell from three independent experiments was generated by LASX. </a:t>
            </a:r>
            <a:endParaRPr lang="en-US" sz="18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646618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3</Words>
  <Application>Microsoft Macintosh PowerPoint</Application>
  <PresentationFormat>Widescreen</PresentationFormat>
  <Paragraphs>3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oah Carrillo</dc:creator>
  <cp:lastModifiedBy>Noah Carrillo</cp:lastModifiedBy>
  <cp:revision>1</cp:revision>
  <dcterms:created xsi:type="dcterms:W3CDTF">2025-12-16T14:32:49Z</dcterms:created>
  <dcterms:modified xsi:type="dcterms:W3CDTF">2025-12-16T14:36:25Z</dcterms:modified>
</cp:coreProperties>
</file>